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29A0B-7502-4C34-8B64-7B0167DEC8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BDA78D-6CE1-4C9D-AB69-1773D032A6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510A27-690C-46AA-883E-0A198FB6B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9AFB5-1F07-49F6-A20D-DC4347C54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42C903-58CF-421D-97CC-5471D9AC4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3122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68956D-6483-496D-A2BF-3FC9B360C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06FAD3-2FB6-42B5-AB54-8228368B4D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46828-FEE2-45F9-AD30-59EA9B458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E8361D-28F0-42E7-82B4-966D1F813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AACEB2-A79A-4DF3-9909-3E118F617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6063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9D4490-3136-405A-9F55-2CB0B68362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383D6B-C7E2-4FF1-8D90-1C12DA2FD3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C3A606-1A06-4707-BCA2-E2E346407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2EA943-15CC-402A-897E-F49AEEA69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89CEC3-AD51-4B03-9641-91C5AC55B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5206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0EE11-5D4B-4C01-8668-34C8A759C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5BBA3D-2DA2-4B68-AA6C-AD48D4420D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035D7E-DE89-4701-B12F-3E5906911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E56511-E2BE-46A1-8C99-F232AA928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347366-8CA4-4069-991C-08D35AF850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7537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78C3A-A44D-4452-86DE-11FD3BAF46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F9C91B-9110-4051-B8AA-85275D743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61EB4C-A28D-4310-AB98-B6DDA3F7F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B6F33B-F4FF-4430-A0B9-C9B55EC5B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BC9752-9D3A-4099-AE5E-ACEE279A0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4988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37CF90-7B51-4F43-9B3A-CF91CCCBB2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4F48BD-833C-4155-AE2B-ACA80596CB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BADB13-7E25-4FE4-8005-8B56CB69E5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BA131B-5474-474D-9FF2-ABF41CF59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14088C-4A56-4B83-8ECE-BB4541015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8306AC-378C-4D66-A700-DFDE7B9EF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8336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76436-549C-46CE-AA85-885D1184C0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0EEBD4-D70D-4E7C-9349-0FB7C5C21B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88115-D67E-4975-BA40-934C981C01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3CB290-301F-4A6C-B3A3-3D073CC1C8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3F7A5C-804F-49D5-978D-C220F23D62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E929C9-A663-4AF4-ACE8-35B8FD727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7B7BF8-5DD7-4045-9BEF-26AD1CBE3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309E2A-F02A-4A74-B8AD-6DC524C57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3088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C408F-40A9-4205-A5A9-4443A6612F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3E5E6E-A8F0-4AEF-942B-2159C92F7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CB337A-99C9-4AF9-BC84-440DA73F3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E7A497-B536-4F7C-AD80-50266C9BC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9616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2C5D6A-4E55-49E1-8038-67915A727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5E68755-216B-4349-8F27-A794799D6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E95D88-2AC0-4C49-B028-8695DF19D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6159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D8B9F9-6935-4A4B-933D-4204A099AA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45E56F-761F-48F5-81E5-815DD458A0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257B29-6F33-4F8C-9FF6-BD925AAB2C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7821E1-064B-48E1-9F9F-21F4B46A8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DC815-0ECF-4D01-B834-49A6822AC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F6A687-31DC-44E5-8A73-B94B3227F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5648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9D5F6-906B-4D74-92BD-E41E4B1F8A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6E3B82-4432-4BE7-97D1-69EF153ED1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346A93-B252-445F-86DD-9545381157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66BD90-6C07-49C7-99C5-49F78988D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A1E382-2F9F-43A1-B09A-9BF42249C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C0C73D-CF04-4A22-9FBC-7A671DDE0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6847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54D4BB-DCD7-424C-8752-ADD42092E4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B80E32-E933-4445-B546-295DEE1133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8E516-3966-49ED-AF84-64604C62CE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4F7858-F18D-42F1-97E6-A6C4D36AA9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A7E24C-E517-466E-A77E-CC5EDE51B9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6335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5" Type="http://schemas.openxmlformats.org/officeDocument/2006/relationships/image" Target="../media/image2.jp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254 NIT 32 BV6171">
            <a:hlinkClick r:id="" action="ppaction://media"/>
            <a:extLst>
              <a:ext uri="{FF2B5EF4-FFF2-40B4-BE49-F238E27FC236}">
                <a16:creationId xmlns:a16="http://schemas.microsoft.com/office/drawing/2014/main" id="{6A7DB114-C7DA-4823-B9C6-7BFA7585F17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 rot="10800000">
            <a:off x="834500" y="578612"/>
            <a:ext cx="4715935" cy="19993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D81217B-9102-4B53-82B8-E38E6D3EF75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834500" y="2809497"/>
            <a:ext cx="4715934" cy="188994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C4FA801-D84B-4495-9533-C62F13583068}"/>
              </a:ext>
            </a:extLst>
          </p:cNvPr>
          <p:cNvSpPr txBox="1"/>
          <p:nvPr/>
        </p:nvSpPr>
        <p:spPr>
          <a:xfrm>
            <a:off x="721864" y="4930968"/>
            <a:ext cx="482857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vie S5</a:t>
            </a: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ampl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me-laps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vi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xed species in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fluidic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ip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wing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MH media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ed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 antibiotic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trofurantoin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p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pectiv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SH image (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ttom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movie is generated from the time-lapse phase contrast images with time intervals of 120 sec and playback speed of the video is 5 fps.</a:t>
            </a:r>
          </a:p>
          <a:p>
            <a:pPr algn="just"/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90361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4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58</Words>
  <Application>Microsoft Office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odh Kandavalli</dc:creator>
  <cp:lastModifiedBy>Vinodh Kandavalli</cp:lastModifiedBy>
  <cp:revision>17</cp:revision>
  <dcterms:created xsi:type="dcterms:W3CDTF">2021-08-13T05:45:58Z</dcterms:created>
  <dcterms:modified xsi:type="dcterms:W3CDTF">2022-09-21T11:47:33Z</dcterms:modified>
</cp:coreProperties>
</file>